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2082F0-E2DB-467A-943A-DFC87E512CF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B79BD2-B524-4647-92FB-DD03C6D9AB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ECC162-EA6A-4A2C-8C9C-FE13741AE7C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ABC3A5-3CBE-43DD-86E4-3A79A94ED83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FE7F77-9373-46AD-A245-2409E27B7A7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350D45-52F8-4F15-B328-7082A1CCF51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C22BA2-B20E-46D0-B0B9-7A95CD5C31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89E3E5-F552-4D5A-83F9-3914FF0550D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4F7EF8-7DE5-4AC9-B365-A153D5659F6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7D2661-A34E-4F36-A63E-164CF3F905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0FAFDE-970F-4E3F-965E-7491A7B762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B72F61-BC07-4DD0-AA6C-1DDF0FAC86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A898619-CE71-4700-BD0A-73FCDC1668C7}" type="datetime">
              <a:rPr b="0" lang="ja-JP" sz="12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23F4FCD-2A38-4280-A41A-72171EB35127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図 128" descr=""/>
          <p:cNvPicPr/>
          <p:nvPr/>
        </p:nvPicPr>
        <p:blipFill>
          <a:blip r:embed="rId1"/>
          <a:stretch/>
        </p:blipFill>
        <p:spPr>
          <a:xfrm>
            <a:off x="507960" y="952560"/>
            <a:ext cx="3898800" cy="3162240"/>
          </a:xfrm>
          <a:prstGeom prst="rect">
            <a:avLst/>
          </a:prstGeom>
          <a:ln w="0">
            <a:noFill/>
          </a:ln>
        </p:spPr>
      </p:pic>
      <p:pic>
        <p:nvPicPr>
          <p:cNvPr id="42" name="図 129" descr=""/>
          <p:cNvPicPr/>
          <p:nvPr/>
        </p:nvPicPr>
        <p:blipFill>
          <a:blip r:embed="rId2"/>
          <a:stretch/>
        </p:blipFill>
        <p:spPr>
          <a:xfrm>
            <a:off x="4800600" y="927000"/>
            <a:ext cx="3952800" cy="3194280"/>
          </a:xfrm>
          <a:prstGeom prst="rect">
            <a:avLst/>
          </a:prstGeom>
          <a:ln w="0">
            <a:noFill/>
          </a:ln>
        </p:spPr>
      </p:pic>
      <p:sp>
        <p:nvSpPr>
          <p:cNvPr id="43" name="正方形/長方形 16"/>
          <p:cNvSpPr/>
          <p:nvPr/>
        </p:nvSpPr>
        <p:spPr>
          <a:xfrm>
            <a:off x="469800" y="5051520"/>
            <a:ext cx="843300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Figure S2   Comparison of tag abundance between HT-SuperSAGE and original SuperSAGE after removal of tags harboring homopolymer sequences and tags, which did not completely matched rice and </a:t>
            </a: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Magnaporthe grisea 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nome sequences from dataset in Figure 3</a:t>
            </a: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.  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riteria of tag removal was described in the text.   (panel A for sample f and panel B for sample l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テキスト ボックス 21"/>
          <p:cNvSpPr/>
          <p:nvPr/>
        </p:nvSpPr>
        <p:spPr>
          <a:xfrm rot="16200000">
            <a:off x="-1152000" y="2036160"/>
            <a:ext cx="3100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ag count (original SuperSAGE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テキスト ボックス 13"/>
          <p:cNvSpPr/>
          <p:nvPr/>
        </p:nvSpPr>
        <p:spPr>
          <a:xfrm>
            <a:off x="249120" y="571680"/>
            <a:ext cx="507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テキスト ボックス 19"/>
          <p:cNvSpPr/>
          <p:nvPr/>
        </p:nvSpPr>
        <p:spPr>
          <a:xfrm>
            <a:off x="1351080" y="4127400"/>
            <a:ext cx="3098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ag count (HT-SuperSAGE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テキスト ボックス 21"/>
          <p:cNvSpPr/>
          <p:nvPr/>
        </p:nvSpPr>
        <p:spPr>
          <a:xfrm rot="16200000">
            <a:off x="3152880" y="1922040"/>
            <a:ext cx="3100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ag count (original SuperSAGE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テキスト ボックス 13"/>
          <p:cNvSpPr/>
          <p:nvPr/>
        </p:nvSpPr>
        <p:spPr>
          <a:xfrm>
            <a:off x="4554360" y="457200"/>
            <a:ext cx="5083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テキスト ボックス 19"/>
          <p:cNvSpPr/>
          <p:nvPr/>
        </p:nvSpPr>
        <p:spPr>
          <a:xfrm>
            <a:off x="5478480" y="4102200"/>
            <a:ext cx="309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ag count (HT-SuperSAGE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30T01:24:55Z</dcterms:created>
  <dc:creator>松村 英生</dc:creator>
  <dc:description/>
  <dc:language>en-US</dc:language>
  <cp:lastModifiedBy>松村 英生</cp:lastModifiedBy>
  <dcterms:modified xsi:type="dcterms:W3CDTF">2010-04-30T07:12:48Z</dcterms:modified>
  <cp:revision>10</cp:revision>
  <dc:subject/>
  <dc:title>スライド 1</dc:title>
</cp:coreProperties>
</file>